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5"/>
  </p:notesMasterIdLst>
  <p:sldIdLst>
    <p:sldId id="290" r:id="rId2"/>
    <p:sldId id="299" r:id="rId3"/>
    <p:sldId id="292" r:id="rId4"/>
  </p:sldIdLst>
  <p:sldSz cx="6492875" cy="6218238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437" userDrawn="1">
          <p15:clr>
            <a:srgbClr val="A4A3A4"/>
          </p15:clr>
        </p15:guide>
        <p15:guide id="3" orient="horz" pos="375" userDrawn="1">
          <p15:clr>
            <a:srgbClr val="A4A3A4"/>
          </p15:clr>
        </p15:guide>
        <p15:guide id="4" pos="1349" userDrawn="1">
          <p15:clr>
            <a:srgbClr val="A4A3A4"/>
          </p15:clr>
        </p15:guide>
        <p15:guide id="5" orient="horz" pos="203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udhary, Ritu" initials="CR" lastIdx="1" clrIdx="0">
    <p:extLst>
      <p:ext uri="{19B8F6BF-5375-455C-9EA6-DF929625EA0E}">
        <p15:presenceInfo xmlns:p15="http://schemas.microsoft.com/office/powerpoint/2012/main" userId="S::Ritu.Chaudhary@moffitt.org::e213b328-12f3-42f9-9afb-2fdf354946f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0D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32" autoAdjust="0"/>
    <p:restoredTop sz="90099" autoAdjust="0"/>
  </p:normalViewPr>
  <p:slideViewPr>
    <p:cSldViewPr snapToGrid="0">
      <p:cViewPr varScale="1">
        <p:scale>
          <a:sx n="160" d="100"/>
          <a:sy n="160" d="100"/>
        </p:scale>
        <p:origin x="3736" y="84"/>
      </p:cViewPr>
      <p:guideLst>
        <p:guide pos="3437"/>
        <p:guide orient="horz" pos="375"/>
        <p:guide pos="1349"/>
        <p:guide orient="horz" pos="203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E3D79D2C-534C-49B8-BF89-98F21FED85F5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71663" y="1163638"/>
            <a:ext cx="32797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3FBF2B51-D0C1-4CC3-B696-54FB44FD7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84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76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52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628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504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79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255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131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3007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017661"/>
            <a:ext cx="5518944" cy="2164868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3266015"/>
            <a:ext cx="4869656" cy="1501301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752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62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331064"/>
            <a:ext cx="1400026" cy="5269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331064"/>
            <a:ext cx="4118918" cy="5269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30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61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1550243"/>
            <a:ext cx="5600105" cy="2586614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4161327"/>
            <a:ext cx="5600105" cy="136023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/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75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75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30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408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331065"/>
            <a:ext cx="5600105" cy="12019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1524332"/>
            <a:ext cx="2746790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2271384"/>
            <a:ext cx="2746790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1524332"/>
            <a:ext cx="2760318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2271384"/>
            <a:ext cx="2760318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70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3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78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895313"/>
            <a:ext cx="3287018" cy="4418979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8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895313"/>
            <a:ext cx="3287018" cy="4418979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0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331065"/>
            <a:ext cx="5600105" cy="12019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1655318"/>
            <a:ext cx="5600105" cy="39454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5763387"/>
            <a:ext cx="2191345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25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C1A9E38-D437-4D83-AFA9-6647D04F4B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519" y="633618"/>
            <a:ext cx="1821786" cy="182691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97A46CC-A0C5-420A-8FB9-D9B3469FE4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9555" y="633618"/>
            <a:ext cx="1880802" cy="182691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D2F700A-397D-4692-A03D-2B9F352E16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85891" y="630912"/>
            <a:ext cx="1924423" cy="180639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AD72A99-826E-4403-BF30-D6D8473C5AD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3519" y="3182088"/>
            <a:ext cx="1816655" cy="185257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67CB777-D757-47D1-95A4-D7286DF5F8A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79554" y="3182088"/>
            <a:ext cx="1893632" cy="185257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5393E6B-7F49-4B4A-9053-2482455902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85891" y="3182088"/>
            <a:ext cx="1929555" cy="185257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03D6DB5-CD69-4B0A-A492-F9D481604AD3}"/>
              </a:ext>
            </a:extLst>
          </p:cNvPr>
          <p:cNvSpPr txBox="1"/>
          <p:nvPr/>
        </p:nvSpPr>
        <p:spPr>
          <a:xfrm>
            <a:off x="273519" y="612434"/>
            <a:ext cx="1145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F5CB45-38E0-4194-9241-E1582404D12F}"/>
              </a:ext>
            </a:extLst>
          </p:cNvPr>
          <p:cNvSpPr txBox="1"/>
          <p:nvPr/>
        </p:nvSpPr>
        <p:spPr>
          <a:xfrm>
            <a:off x="2279554" y="612434"/>
            <a:ext cx="1145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xtur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CB8769E-0184-4A3A-89FF-A7EA64B44C41}"/>
              </a:ext>
            </a:extLst>
          </p:cNvPr>
          <p:cNvSpPr txBox="1"/>
          <p:nvPr/>
        </p:nvSpPr>
        <p:spPr>
          <a:xfrm>
            <a:off x="4385891" y="612434"/>
            <a:ext cx="1145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30EADD7-C7EE-4250-8886-03FD1A62CB0A}"/>
              </a:ext>
            </a:extLst>
          </p:cNvPr>
          <p:cNvSpPr txBox="1"/>
          <p:nvPr/>
        </p:nvSpPr>
        <p:spPr>
          <a:xfrm>
            <a:off x="235419" y="3195795"/>
            <a:ext cx="1145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7AE8EE4-1E77-4713-8AA9-926EF08C4F33}"/>
              </a:ext>
            </a:extLst>
          </p:cNvPr>
          <p:cNvSpPr txBox="1"/>
          <p:nvPr/>
        </p:nvSpPr>
        <p:spPr>
          <a:xfrm>
            <a:off x="2241454" y="3195795"/>
            <a:ext cx="1145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xtu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EA41AD9-3B8B-4E0D-A80B-1C129F5CD9B5}"/>
              </a:ext>
            </a:extLst>
          </p:cNvPr>
          <p:cNvSpPr txBox="1"/>
          <p:nvPr/>
        </p:nvSpPr>
        <p:spPr>
          <a:xfrm>
            <a:off x="4347791" y="3195795"/>
            <a:ext cx="1145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CAD3B1-6841-45F9-B7FB-13B5886F767E}"/>
              </a:ext>
            </a:extLst>
          </p:cNvPr>
          <p:cNvSpPr txBox="1"/>
          <p:nvPr/>
        </p:nvSpPr>
        <p:spPr>
          <a:xfrm rot="16200000">
            <a:off x="-298360" y="1300992"/>
            <a:ext cx="9429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ymphoi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01DC07-C249-4C09-B7FF-BE343545AA0E}"/>
              </a:ext>
            </a:extLst>
          </p:cNvPr>
          <p:cNvSpPr txBox="1"/>
          <p:nvPr/>
        </p:nvSpPr>
        <p:spPr>
          <a:xfrm rot="16200000">
            <a:off x="-298360" y="3990912"/>
            <a:ext cx="9429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yeloi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214297-5A5A-4A30-9B16-D4900C4159B2}"/>
              </a:ext>
            </a:extLst>
          </p:cNvPr>
          <p:cNvSpPr txBox="1"/>
          <p:nvPr/>
        </p:nvSpPr>
        <p:spPr>
          <a:xfrm>
            <a:off x="4818185" y="22987"/>
            <a:ext cx="1566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E304DB7-49B0-430D-AE2D-BC8F606242D1}"/>
              </a:ext>
            </a:extLst>
          </p:cNvPr>
          <p:cNvSpPr txBox="1"/>
          <p:nvPr/>
        </p:nvSpPr>
        <p:spPr>
          <a:xfrm>
            <a:off x="-39892" y="323309"/>
            <a:ext cx="399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A9B2202-9C23-4076-8683-5BCCB61D5ED1}"/>
              </a:ext>
            </a:extLst>
          </p:cNvPr>
          <p:cNvSpPr txBox="1"/>
          <p:nvPr/>
        </p:nvSpPr>
        <p:spPr>
          <a:xfrm>
            <a:off x="-40789" y="2944681"/>
            <a:ext cx="3992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E5C5239-BB0E-47DF-AC73-505C42E325FC}"/>
              </a:ext>
            </a:extLst>
          </p:cNvPr>
          <p:cNvSpPr txBox="1"/>
          <p:nvPr/>
        </p:nvSpPr>
        <p:spPr>
          <a:xfrm>
            <a:off x="173097" y="5111843"/>
            <a:ext cx="621155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:</a:t>
            </a:r>
            <a:endParaRPr lang="en-U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, B) Representative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IHC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mages showing staining of nuclei (blue), tumor cell (orange - PCK) and selected immune checkpoint markers in each molecular subgroup. (A) Images show four lymphoid markers - CD3</a:t>
            </a:r>
            <a:r>
              <a:rPr lang="en-US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-cells (Green), CD8</a:t>
            </a:r>
            <a:r>
              <a:rPr lang="en-US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ytotoxic T-cells (Yellow), CD69</a:t>
            </a:r>
            <a:r>
              <a:rPr lang="en-US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ctivated T-cells (Red) and CD103</a:t>
            </a:r>
            <a:r>
              <a:rPr lang="en-US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resident memory T-cells (Cyan). (B) Images show three myeloid markers – HLA-DR</a:t>
            </a:r>
            <a:r>
              <a:rPr lang="en-US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PCs (Green), MHCII</a:t>
            </a:r>
            <a:r>
              <a:rPr lang="en-US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PCs (Cyan) and CD163</a:t>
            </a:r>
            <a:r>
              <a:rPr lang="en-US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M2 macrophages (Yellow). 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73546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D385C81-2DB9-47B3-A15E-F6C3704E7AB3}"/>
              </a:ext>
            </a:extLst>
          </p:cNvPr>
          <p:cNvSpPr txBox="1"/>
          <p:nvPr/>
        </p:nvSpPr>
        <p:spPr>
          <a:xfrm>
            <a:off x="4964707" y="-6680"/>
            <a:ext cx="1609950" cy="248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B8E68C-D328-491D-863C-1445027BDCE4}"/>
              </a:ext>
            </a:extLst>
          </p:cNvPr>
          <p:cNvSpPr txBox="1"/>
          <p:nvPr/>
        </p:nvSpPr>
        <p:spPr>
          <a:xfrm>
            <a:off x="-25955" y="269208"/>
            <a:ext cx="3629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FBC06FFE-9167-40C5-8DED-41656D6466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985" y="440308"/>
            <a:ext cx="4003217" cy="266881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6633C3B-FF62-415B-A203-DBCDC7DB6671}"/>
              </a:ext>
            </a:extLst>
          </p:cNvPr>
          <p:cNvSpPr txBox="1"/>
          <p:nvPr/>
        </p:nvSpPr>
        <p:spPr>
          <a:xfrm>
            <a:off x="440473" y="3489037"/>
            <a:ext cx="57701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: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C) Linear model showing correlation between PD-L1 CPS and Immune, Mixture and Hypoxia subgroup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532957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94D0F8-F961-4BA7-A490-2E941DB399E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276"/>
          <a:stretch/>
        </p:blipFill>
        <p:spPr>
          <a:xfrm>
            <a:off x="105416" y="537882"/>
            <a:ext cx="2012167" cy="188588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C6A6BB1-6BC1-42C2-AC56-1534D4C403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276"/>
          <a:stretch/>
        </p:blipFill>
        <p:spPr>
          <a:xfrm>
            <a:off x="2267421" y="537881"/>
            <a:ext cx="2012167" cy="1885882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9FBF7B9-FE06-4299-B433-5425E303392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276"/>
          <a:stretch/>
        </p:blipFill>
        <p:spPr>
          <a:xfrm>
            <a:off x="4418218" y="537881"/>
            <a:ext cx="2012167" cy="188588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93B4F16-6F79-4BE7-B828-EE1CC5549CC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6276"/>
          <a:stretch/>
        </p:blipFill>
        <p:spPr>
          <a:xfrm>
            <a:off x="105416" y="2928278"/>
            <a:ext cx="2012167" cy="188588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E65CDA7-8F58-4D97-9CAE-D8EF2A6E9B8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6276"/>
          <a:stretch/>
        </p:blipFill>
        <p:spPr>
          <a:xfrm>
            <a:off x="2267421" y="2928278"/>
            <a:ext cx="2012167" cy="188588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4206591-EFF8-44DA-87D1-754BF48628F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119"/>
          <a:stretch/>
        </p:blipFill>
        <p:spPr>
          <a:xfrm>
            <a:off x="4418218" y="2925103"/>
            <a:ext cx="2012167" cy="188905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D385C81-2DB9-47B3-A15E-F6C3704E7AB3}"/>
              </a:ext>
            </a:extLst>
          </p:cNvPr>
          <p:cNvSpPr txBox="1"/>
          <p:nvPr/>
        </p:nvSpPr>
        <p:spPr>
          <a:xfrm>
            <a:off x="4964707" y="-6680"/>
            <a:ext cx="1609950" cy="248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B8E68C-D328-491D-863C-1445027BDCE4}"/>
              </a:ext>
            </a:extLst>
          </p:cNvPr>
          <p:cNvSpPr txBox="1"/>
          <p:nvPr/>
        </p:nvSpPr>
        <p:spPr>
          <a:xfrm>
            <a:off x="-25955" y="269208"/>
            <a:ext cx="3629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F25EB22-7309-4284-B1EB-50C92C19078A}"/>
              </a:ext>
            </a:extLst>
          </p:cNvPr>
          <p:cNvSpPr txBox="1"/>
          <p:nvPr/>
        </p:nvSpPr>
        <p:spPr>
          <a:xfrm>
            <a:off x="798295" y="322787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C7363F7-B636-49AD-BBEF-72EBA3F53578}"/>
              </a:ext>
            </a:extLst>
          </p:cNvPr>
          <p:cNvSpPr txBox="1"/>
          <p:nvPr/>
        </p:nvSpPr>
        <p:spPr>
          <a:xfrm>
            <a:off x="2952020" y="322787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HCII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E3E9041-EEFF-4816-BD7D-D01C9E7064A0}"/>
              </a:ext>
            </a:extLst>
          </p:cNvPr>
          <p:cNvSpPr txBox="1"/>
          <p:nvPr/>
        </p:nvSpPr>
        <p:spPr>
          <a:xfrm>
            <a:off x="4854031" y="322787"/>
            <a:ext cx="11405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HCII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04322D4-38E2-45B9-87F9-7976357624D1}"/>
              </a:ext>
            </a:extLst>
          </p:cNvPr>
          <p:cNvSpPr txBox="1"/>
          <p:nvPr/>
        </p:nvSpPr>
        <p:spPr>
          <a:xfrm>
            <a:off x="798295" y="2723213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15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33510AB-43FA-4DF0-9587-DBB5D2261D77}"/>
              </a:ext>
            </a:extLst>
          </p:cNvPr>
          <p:cNvSpPr txBox="1"/>
          <p:nvPr/>
        </p:nvSpPr>
        <p:spPr>
          <a:xfrm>
            <a:off x="2960300" y="2723213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66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0C3B01-0913-4630-BE41-B3DCEEE252C7}"/>
              </a:ext>
            </a:extLst>
          </p:cNvPr>
          <p:cNvSpPr txBox="1"/>
          <p:nvPr/>
        </p:nvSpPr>
        <p:spPr>
          <a:xfrm>
            <a:off x="5043401" y="2723213"/>
            <a:ext cx="7783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-SIGN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87F6044-B1A3-4E6A-9FAA-D15D333CD2E3}"/>
              </a:ext>
            </a:extLst>
          </p:cNvPr>
          <p:cNvSpPr txBox="1"/>
          <p:nvPr/>
        </p:nvSpPr>
        <p:spPr>
          <a:xfrm>
            <a:off x="-25955" y="2687342"/>
            <a:ext cx="3629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8BC8003-5D0B-42FA-B9A3-F146C9CCB865}"/>
              </a:ext>
            </a:extLst>
          </p:cNvPr>
          <p:cNvSpPr txBox="1"/>
          <p:nvPr/>
        </p:nvSpPr>
        <p:spPr>
          <a:xfrm>
            <a:off x="178842" y="4954837"/>
            <a:ext cx="625154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: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D-E) Boxplots showing cell counts distribution of different immune markers among the primary (n = 63) and recurrent (n = 20) tumors in TMA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IHC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ohort. Students t-tests were used to test for significant differences between the groups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03698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715</TotalTime>
  <Words>210</Words>
  <Application>Microsoft Office PowerPoint</Application>
  <PresentationFormat>Custom</PresentationFormat>
  <Paragraphs>2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udhary, Ritu</dc:creator>
  <cp:lastModifiedBy>Chung, Christine H</cp:lastModifiedBy>
  <cp:revision>383</cp:revision>
  <cp:lastPrinted>2022-01-03T15:25:01Z</cp:lastPrinted>
  <dcterms:created xsi:type="dcterms:W3CDTF">2021-01-11T21:01:01Z</dcterms:created>
  <dcterms:modified xsi:type="dcterms:W3CDTF">2023-04-30T13:07:16Z</dcterms:modified>
</cp:coreProperties>
</file>